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92" r:id="rId1"/>
  </p:sldMasterIdLst>
  <p:notesMasterIdLst>
    <p:notesMasterId r:id="rId3"/>
  </p:notesMasterIdLst>
  <p:sldIdLst>
    <p:sldId id="256" r:id="rId2"/>
  </p:sldIdLst>
  <p:sldSz cx="11879263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94" autoAdjust="0"/>
  </p:normalViewPr>
  <p:slideViewPr>
    <p:cSldViewPr snapToGrid="0">
      <p:cViewPr varScale="1">
        <p:scale>
          <a:sx n="66" d="100"/>
          <a:sy n="66" d="100"/>
        </p:scale>
        <p:origin x="64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7650" y="1143000"/>
            <a:ext cx="6362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1pPr>
    <a:lvl2pPr marL="440012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2pPr>
    <a:lvl3pPr marL="880022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3pPr>
    <a:lvl4pPr marL="1320034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4pPr>
    <a:lvl5pPr marL="1760046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5pPr>
    <a:lvl6pPr marL="2200057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6pPr>
    <a:lvl7pPr marL="2640068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7pPr>
    <a:lvl8pPr marL="3080079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8pPr>
    <a:lvl9pPr marL="3520091" algn="l" defTabSz="880022" rtl="0" eaLnBrk="1" latinLnBrk="0" hangingPunct="1">
      <a:defRPr sz="115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7650" y="1143000"/>
            <a:ext cx="6362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4908" y="942577"/>
            <a:ext cx="8909447" cy="2005142"/>
          </a:xfrm>
        </p:spPr>
        <p:txBody>
          <a:bodyPr anchor="b"/>
          <a:lstStyle>
            <a:lvl1pPr algn="ctr"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4908" y="3025045"/>
            <a:ext cx="8909447" cy="1390533"/>
          </a:xfrm>
        </p:spPr>
        <p:txBody>
          <a:bodyPr/>
          <a:lstStyle>
            <a:lvl1pPr marL="0" indent="0" algn="ctr">
              <a:buNone/>
              <a:defRPr sz="2016"/>
            </a:lvl1pPr>
            <a:lvl2pPr marL="383957" indent="0" algn="ctr">
              <a:buNone/>
              <a:defRPr sz="1680"/>
            </a:lvl2pPr>
            <a:lvl3pPr marL="767913" indent="0" algn="ctr">
              <a:buNone/>
              <a:defRPr sz="1512"/>
            </a:lvl3pPr>
            <a:lvl4pPr marL="1151870" indent="0" algn="ctr">
              <a:buNone/>
              <a:defRPr sz="1344"/>
            </a:lvl4pPr>
            <a:lvl5pPr marL="1535826" indent="0" algn="ctr">
              <a:buNone/>
              <a:defRPr sz="1344"/>
            </a:lvl5pPr>
            <a:lvl6pPr marL="1919783" indent="0" algn="ctr">
              <a:buNone/>
              <a:defRPr sz="1344"/>
            </a:lvl6pPr>
            <a:lvl7pPr marL="2303739" indent="0" algn="ctr">
              <a:buNone/>
              <a:defRPr sz="1344"/>
            </a:lvl7pPr>
            <a:lvl8pPr marL="2687696" indent="0" algn="ctr">
              <a:buNone/>
              <a:defRPr sz="1344"/>
            </a:lvl8pPr>
            <a:lvl9pPr marL="3071652" indent="0" algn="ctr">
              <a:buNone/>
              <a:defRPr sz="13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2932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95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1098" y="306637"/>
            <a:ext cx="2561466" cy="48808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700" y="306637"/>
            <a:ext cx="7535907" cy="488086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80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9023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512" y="1435864"/>
            <a:ext cx="10245864" cy="2395771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512" y="3854300"/>
            <a:ext cx="10245864" cy="1259879"/>
          </a:xfrm>
        </p:spPr>
        <p:txBody>
          <a:bodyPr/>
          <a:lstStyle>
            <a:lvl1pPr marL="0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1pPr>
            <a:lvl2pPr marL="383957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2pPr>
            <a:lvl3pPr marL="767913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3pPr>
            <a:lvl4pPr marL="1151870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4pPr>
            <a:lvl5pPr marL="153582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5pPr>
            <a:lvl6pPr marL="1919783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6pPr>
            <a:lvl7pPr marL="2303739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7pPr>
            <a:lvl8pPr marL="268769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8pPr>
            <a:lvl9pPr marL="3071652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3229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699" y="1533187"/>
            <a:ext cx="5048687" cy="365431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3877" y="1533187"/>
            <a:ext cx="5048687" cy="365431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9991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306638"/>
            <a:ext cx="10245864" cy="111322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247" y="1411865"/>
            <a:ext cx="5025485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247" y="2103799"/>
            <a:ext cx="5025485" cy="309437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3877" y="1411865"/>
            <a:ext cx="5050234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3877" y="2103799"/>
            <a:ext cx="5050234" cy="309437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476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262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475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383963"/>
            <a:ext cx="3831371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234" y="829255"/>
            <a:ext cx="6013877" cy="4092942"/>
          </a:xfrm>
        </p:spPr>
        <p:txBody>
          <a:bodyPr/>
          <a:lstStyle>
            <a:lvl1pPr>
              <a:defRPr sz="2687"/>
            </a:lvl1pPr>
            <a:lvl2pPr>
              <a:defRPr sz="2351"/>
            </a:lvl2pPr>
            <a:lvl3pPr>
              <a:defRPr sz="2016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7" y="1727835"/>
            <a:ext cx="3831371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2620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383963"/>
            <a:ext cx="3831371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234" y="829255"/>
            <a:ext cx="6013877" cy="4092942"/>
          </a:xfrm>
        </p:spPr>
        <p:txBody>
          <a:bodyPr anchor="t"/>
          <a:lstStyle>
            <a:lvl1pPr marL="0" indent="0">
              <a:buNone/>
              <a:defRPr sz="2687"/>
            </a:lvl1pPr>
            <a:lvl2pPr marL="383957" indent="0">
              <a:buNone/>
              <a:defRPr sz="2351"/>
            </a:lvl2pPr>
            <a:lvl3pPr marL="767913" indent="0">
              <a:buNone/>
              <a:defRPr sz="2016"/>
            </a:lvl3pPr>
            <a:lvl4pPr marL="1151870" indent="0">
              <a:buNone/>
              <a:defRPr sz="1680"/>
            </a:lvl4pPr>
            <a:lvl5pPr marL="1535826" indent="0">
              <a:buNone/>
              <a:defRPr sz="1680"/>
            </a:lvl5pPr>
            <a:lvl6pPr marL="1919783" indent="0">
              <a:buNone/>
              <a:defRPr sz="1680"/>
            </a:lvl6pPr>
            <a:lvl7pPr marL="2303739" indent="0">
              <a:buNone/>
              <a:defRPr sz="1680"/>
            </a:lvl7pPr>
            <a:lvl8pPr marL="2687696" indent="0">
              <a:buNone/>
              <a:defRPr sz="1680"/>
            </a:lvl8pPr>
            <a:lvl9pPr marL="3071652" indent="0">
              <a:buNone/>
              <a:defRPr sz="168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7" y="1727835"/>
            <a:ext cx="3831371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3867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700" y="306638"/>
            <a:ext cx="10245864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700" y="1533187"/>
            <a:ext cx="10245864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699" y="5338158"/>
            <a:ext cx="2672834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006" y="5338158"/>
            <a:ext cx="4009251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9730" y="5338158"/>
            <a:ext cx="2672834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321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3" r:id="rId1"/>
    <p:sldLayoutId id="2147483794" r:id="rId2"/>
    <p:sldLayoutId id="2147483795" r:id="rId3"/>
    <p:sldLayoutId id="2147483796" r:id="rId4"/>
    <p:sldLayoutId id="2147483797" r:id="rId5"/>
    <p:sldLayoutId id="2147483798" r:id="rId6"/>
    <p:sldLayoutId id="2147483799" r:id="rId7"/>
    <p:sldLayoutId id="2147483800" r:id="rId8"/>
    <p:sldLayoutId id="2147483801" r:id="rId9"/>
    <p:sldLayoutId id="2147483802" r:id="rId10"/>
    <p:sldLayoutId id="2147483803" r:id="rId11"/>
  </p:sldLayoutIdLst>
  <p:txStyles>
    <p:titleStyle>
      <a:lvl1pPr algn="l" defTabSz="767913" rtl="0" eaLnBrk="1" latinLnBrk="0" hangingPunct="1">
        <a:lnSpc>
          <a:spcPct val="90000"/>
        </a:lnSpc>
        <a:spcBef>
          <a:spcPct val="0"/>
        </a:spcBef>
        <a:buNone/>
        <a:defRPr sz="36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1978" indent="-191978" algn="l" defTabSz="76791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2351" kern="1200">
          <a:solidFill>
            <a:schemeClr val="tx1"/>
          </a:solidFill>
          <a:latin typeface="+mn-lt"/>
          <a:ea typeface="+mn-ea"/>
          <a:cs typeface="+mn-cs"/>
        </a:defRPr>
      </a:lvl1pPr>
      <a:lvl2pPr marL="57593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2pPr>
      <a:lvl3pPr marL="95989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34384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72780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211176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49571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879674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26363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1pPr>
      <a:lvl2pPr marL="383957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6791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3pPr>
      <a:lvl4pPr marL="115187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53582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191978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303739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68769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071652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>
            <a:extLst>
              <a:ext uri="{FF2B5EF4-FFF2-40B4-BE49-F238E27FC236}">
                <a16:creationId xmlns:a16="http://schemas.microsoft.com/office/drawing/2014/main" id="{6FA851A9-6850-43D7-B96E-145AD065AB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42429" y="327402"/>
            <a:ext cx="3538880" cy="355899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3224CC3-7B16-4A47-9C05-D17DE2A813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55953" y="327402"/>
            <a:ext cx="3538880" cy="355899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7A59B58-E289-4145-8E0C-1DB34345C3D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6648" y="327402"/>
            <a:ext cx="3538880" cy="355899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44858292-6323-44F9-BC10-E26E83E7D792}"/>
              </a:ext>
            </a:extLst>
          </p:cNvPr>
          <p:cNvSpPr txBox="1"/>
          <p:nvPr/>
        </p:nvSpPr>
        <p:spPr>
          <a:xfrm>
            <a:off x="489498" y="224506"/>
            <a:ext cx="336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A</a:t>
            </a:r>
            <a:endParaRPr lang="zh-CN" altLang="en-US" sz="20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DA9615-25C8-4D47-BF0D-6BDEEB75CFF1}"/>
              </a:ext>
            </a:extLst>
          </p:cNvPr>
          <p:cNvSpPr txBox="1"/>
          <p:nvPr/>
        </p:nvSpPr>
        <p:spPr>
          <a:xfrm>
            <a:off x="4220943" y="224506"/>
            <a:ext cx="2678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B</a:t>
            </a:r>
            <a:endParaRPr lang="zh-CN" altLang="en-US" sz="2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FB0FF61-2ED1-4DFF-B001-B98F0C1ED4C7}"/>
              </a:ext>
            </a:extLst>
          </p:cNvPr>
          <p:cNvSpPr txBox="1"/>
          <p:nvPr/>
        </p:nvSpPr>
        <p:spPr>
          <a:xfrm>
            <a:off x="8052926" y="224506"/>
            <a:ext cx="2343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/>
              <a:t>C</a:t>
            </a:r>
            <a:endParaRPr lang="zh-CN" altLang="en-US" sz="2000" b="1" dirty="0"/>
          </a:p>
        </p:txBody>
      </p:sp>
      <p:sp>
        <p:nvSpPr>
          <p:cNvPr id="33" name="文本框 9">
            <a:extLst>
              <a:ext uri="{FF2B5EF4-FFF2-40B4-BE49-F238E27FC236}">
                <a16:creationId xmlns:a16="http://schemas.microsoft.com/office/drawing/2014/main" id="{54AB5FB8-0749-4AC5-B09A-C7447EFECAB2}"/>
              </a:ext>
            </a:extLst>
          </p:cNvPr>
          <p:cNvSpPr txBox="1"/>
          <p:nvPr/>
        </p:nvSpPr>
        <p:spPr>
          <a:xfrm>
            <a:off x="206805" y="4178755"/>
            <a:ext cx="1147450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10.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alidation of</a:t>
            </a:r>
            <a:r>
              <a:rPr lang="en-US" altLang="zh-CN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cterial species markers for pairwise discriminations of t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CRC, CRA and NC groups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by random forest model with 10-fold cross validation.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eiver operating characteristic (ROC) analysis for the 6 bacteria discriminating CRC from NC using random forest model with 10-fold cross validation.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14 bacteria markers discriminating CRA from NC using random forest model with 10-fold cross validation. </a:t>
            </a:r>
            <a:r>
              <a:rPr lang="en-US" altLang="zh-CN" sz="14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C)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for the 6 bacteria markers discriminating CRC from CRA using random forest model with 10-fold cross validation. </a:t>
            </a:r>
            <a:r>
              <a:rPr lang="en-US" altLang="zh-CN" sz="14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ere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ROC curves were generated by averaging the results for 10-fold cross validation.</a:t>
            </a:r>
            <a:r>
              <a:rPr lang="en-HK" altLang="zh-CN" sz="14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RC; colorectal cancer, CRA; colorectal adenoma, NC; normal control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8">
            <a:extLst>
              <a:ext uri="{FF2B5EF4-FFF2-40B4-BE49-F238E27FC236}">
                <a16:creationId xmlns:a16="http://schemas.microsoft.com/office/drawing/2014/main" id="{722DB974-50E3-403A-ACE0-A13397D9B928}"/>
              </a:ext>
            </a:extLst>
          </p:cNvPr>
          <p:cNvSpPr txBox="1"/>
          <p:nvPr/>
        </p:nvSpPr>
        <p:spPr>
          <a:xfrm>
            <a:off x="4443411" y="3798330"/>
            <a:ext cx="3609515" cy="38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False Positive Percentage (%)</a:t>
            </a:r>
            <a:endParaRPr lang="zh-CN" altLang="en-US" b="1" dirty="0"/>
          </a:p>
        </p:txBody>
      </p:sp>
      <p:sp>
        <p:nvSpPr>
          <p:cNvPr id="35" name="文本框 10">
            <a:extLst>
              <a:ext uri="{FF2B5EF4-FFF2-40B4-BE49-F238E27FC236}">
                <a16:creationId xmlns:a16="http://schemas.microsoft.com/office/drawing/2014/main" id="{44CCA0B2-FFD9-42C2-8E0A-C869795FBBC8}"/>
              </a:ext>
            </a:extLst>
          </p:cNvPr>
          <p:cNvSpPr txBox="1"/>
          <p:nvPr/>
        </p:nvSpPr>
        <p:spPr>
          <a:xfrm rot="16200000">
            <a:off x="-1338696" y="1867910"/>
            <a:ext cx="3609515" cy="38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True Positive Percentage (%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4</TotalTime>
  <Words>143</Words>
  <Application>Microsoft Office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59</cp:revision>
  <dcterms:created xsi:type="dcterms:W3CDTF">2020-10-05T01:00:00Z</dcterms:created>
  <dcterms:modified xsi:type="dcterms:W3CDTF">2021-10-21T15:24:05Z</dcterms:modified>
</cp:coreProperties>
</file>